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8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. Miriam Schulz-Raffelt" initials="DMS" lastIdx="6" clrIdx="0">
    <p:extLst>
      <p:ext uri="{19B8F6BF-5375-455C-9EA6-DF929625EA0E}">
        <p15:presenceInfo xmlns:p15="http://schemas.microsoft.com/office/powerpoint/2012/main" userId="S-1-5-21-1036228674-4065426080-1347446729-9644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74" autoAdjust="0"/>
    <p:restoredTop sz="94660"/>
  </p:normalViewPr>
  <p:slideViewPr>
    <p:cSldViewPr>
      <p:cViewPr varScale="1">
        <p:scale>
          <a:sx n="64" d="100"/>
          <a:sy n="64" d="100"/>
        </p:scale>
        <p:origin x="3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441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944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5166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4047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7185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6927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9584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3229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4613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6891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7953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EBA9C-0EEF-4942-85C2-829E7F9276EC}" type="datetimeFigureOut">
              <a:rPr lang="en-GB" smtClean="0"/>
              <a:t>30/04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6007C-5927-42D9-97C5-9955833BABD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8439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96752" y="6804248"/>
            <a:ext cx="410445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3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etermination of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mpirica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r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babilit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stinguis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u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alse HSP22E/F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act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tner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Blu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o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mpirica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rr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babiliti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cu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inin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i.e.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ic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nsiti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vailabl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ot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non-stress and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tress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ditio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The orang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rv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it o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inin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10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8434" y="1259632"/>
            <a:ext cx="5017764" cy="5434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3540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ichael Schroda</dc:creator>
  <cp:lastModifiedBy>Michael Schroda</cp:lastModifiedBy>
  <cp:revision>132</cp:revision>
  <cp:lastPrinted>2017-03-09T10:05:08Z</cp:lastPrinted>
  <dcterms:created xsi:type="dcterms:W3CDTF">2015-12-19T06:48:26Z</dcterms:created>
  <dcterms:modified xsi:type="dcterms:W3CDTF">2017-04-30T09:33:48Z</dcterms:modified>
</cp:coreProperties>
</file>